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63" r:id="rId2"/>
    <p:sldId id="292" r:id="rId3"/>
    <p:sldId id="290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3300"/>
    <a:srgbClr val="00000C"/>
    <a:srgbClr val="13090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69" autoAdjust="0"/>
    <p:restoredTop sz="94660"/>
  </p:normalViewPr>
  <p:slideViewPr>
    <p:cSldViewPr snapToGrid="0">
      <p:cViewPr varScale="1">
        <p:scale>
          <a:sx n="92" d="100"/>
          <a:sy n="92" d="100"/>
        </p:scale>
        <p:origin x="21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teven Bozinovski" userId="c203fe9d-bb51-4511-9c4c-b966abb8279a" providerId="ADAL" clId="{D0DB233F-B066-4C02-8DC0-E3A52986D462}"/>
    <pc:docChg chg="delSld">
      <pc:chgData name="Steven Bozinovski" userId="c203fe9d-bb51-4511-9c4c-b966abb8279a" providerId="ADAL" clId="{D0DB233F-B066-4C02-8DC0-E3A52986D462}" dt="2023-11-29T23:17:13.497" v="0" actId="47"/>
      <pc:docMkLst>
        <pc:docMk/>
      </pc:docMkLst>
      <pc:sldChg chg="del">
        <pc:chgData name="Steven Bozinovski" userId="c203fe9d-bb51-4511-9c4c-b966abb8279a" providerId="ADAL" clId="{D0DB233F-B066-4C02-8DC0-E3A52986D462}" dt="2023-11-29T23:17:13.497" v="0" actId="47"/>
        <pc:sldMkLst>
          <pc:docMk/>
          <pc:sldMk cId="3438964347" sldId="256"/>
        </pc:sldMkLst>
      </pc:sldChg>
      <pc:sldChg chg="del">
        <pc:chgData name="Steven Bozinovski" userId="c203fe9d-bb51-4511-9c4c-b966abb8279a" providerId="ADAL" clId="{D0DB233F-B066-4C02-8DC0-E3A52986D462}" dt="2023-11-29T23:17:13.497" v="0" actId="47"/>
        <pc:sldMkLst>
          <pc:docMk/>
          <pc:sldMk cId="2073522648" sldId="271"/>
        </pc:sldMkLst>
      </pc:sldChg>
      <pc:sldChg chg="del">
        <pc:chgData name="Steven Bozinovski" userId="c203fe9d-bb51-4511-9c4c-b966abb8279a" providerId="ADAL" clId="{D0DB233F-B066-4C02-8DC0-E3A52986D462}" dt="2023-11-29T23:17:13.497" v="0" actId="47"/>
        <pc:sldMkLst>
          <pc:docMk/>
          <pc:sldMk cId="1696629733" sldId="272"/>
        </pc:sldMkLst>
      </pc:sldChg>
      <pc:sldChg chg="del">
        <pc:chgData name="Steven Bozinovski" userId="c203fe9d-bb51-4511-9c4c-b966abb8279a" providerId="ADAL" clId="{D0DB233F-B066-4C02-8DC0-E3A52986D462}" dt="2023-11-29T23:17:13.497" v="0" actId="47"/>
        <pc:sldMkLst>
          <pc:docMk/>
          <pc:sldMk cId="2752012982" sldId="285"/>
        </pc:sldMkLst>
      </pc:sldChg>
      <pc:sldChg chg="del">
        <pc:chgData name="Steven Bozinovski" userId="c203fe9d-bb51-4511-9c4c-b966abb8279a" providerId="ADAL" clId="{D0DB233F-B066-4C02-8DC0-E3A52986D462}" dt="2023-11-29T23:17:13.497" v="0" actId="47"/>
        <pc:sldMkLst>
          <pc:docMk/>
          <pc:sldMk cId="2133583603" sldId="286"/>
        </pc:sldMkLst>
      </pc:sldChg>
      <pc:sldChg chg="del">
        <pc:chgData name="Steven Bozinovski" userId="c203fe9d-bb51-4511-9c4c-b966abb8279a" providerId="ADAL" clId="{D0DB233F-B066-4C02-8DC0-E3A52986D462}" dt="2023-11-29T23:17:13.497" v="0" actId="47"/>
        <pc:sldMkLst>
          <pc:docMk/>
          <pc:sldMk cId="3242756461" sldId="287"/>
        </pc:sldMkLst>
      </pc:sldChg>
    </pc:docChg>
  </pc:docChgLst>
  <pc:docChgLst>
    <pc:chgData name="Nok Him Fung" userId="4508c454-b486-4a5a-81cc-ecbe86d89fc9" providerId="ADAL" clId="{C0DC07B7-C9F5-4DB4-964D-7E0B5D4DB545}"/>
    <pc:docChg chg="addSld delSld modSld">
      <pc:chgData name="Nok Him Fung" userId="4508c454-b486-4a5a-81cc-ecbe86d89fc9" providerId="ADAL" clId="{C0DC07B7-C9F5-4DB4-964D-7E0B5D4DB545}" dt="2023-11-28T04:29:30.306" v="3" actId="47"/>
      <pc:docMkLst>
        <pc:docMk/>
      </pc:docMkLst>
      <pc:sldChg chg="del">
        <pc:chgData name="Nok Him Fung" userId="4508c454-b486-4a5a-81cc-ecbe86d89fc9" providerId="ADAL" clId="{C0DC07B7-C9F5-4DB4-964D-7E0B5D4DB545}" dt="2023-11-28T04:29:30.306" v="3" actId="47"/>
        <pc:sldMkLst>
          <pc:docMk/>
          <pc:sldMk cId="3744160093" sldId="291"/>
        </pc:sldMkLst>
      </pc:sldChg>
      <pc:sldChg chg="addSp modSp add mod">
        <pc:chgData name="Nok Him Fung" userId="4508c454-b486-4a5a-81cc-ecbe86d89fc9" providerId="ADAL" clId="{C0DC07B7-C9F5-4DB4-964D-7E0B5D4DB545}" dt="2023-11-28T04:29:17.192" v="2" actId="1076"/>
        <pc:sldMkLst>
          <pc:docMk/>
          <pc:sldMk cId="2071257491" sldId="292"/>
        </pc:sldMkLst>
        <pc:spChg chg="add mod">
          <ac:chgData name="Nok Him Fung" userId="4508c454-b486-4a5a-81cc-ecbe86d89fc9" providerId="ADAL" clId="{C0DC07B7-C9F5-4DB4-964D-7E0B5D4DB545}" dt="2023-11-28T04:29:17.192" v="2" actId="1076"/>
          <ac:spMkLst>
            <pc:docMk/>
            <pc:sldMk cId="2071257491" sldId="292"/>
            <ac:spMk id="2" creationId="{C3A44052-6A2F-E908-F84A-CC63A06292C5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B0800B-C5B0-4E82-B9EF-9E360C529723}" type="datetimeFigureOut">
              <a:rPr lang="en-AU" smtClean="0"/>
              <a:t>30/11/2023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A0B2E0-0D1A-4A09-9243-2F63C607531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55831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3C211-CD59-48B5-BB03-990BEF642865}" type="datetimeFigureOut">
              <a:rPr lang="en-AU" smtClean="0"/>
              <a:t>30/11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C696D-C5BD-43F3-998E-8432922331C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49761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3C211-CD59-48B5-BB03-990BEF642865}" type="datetimeFigureOut">
              <a:rPr lang="en-AU" smtClean="0"/>
              <a:t>30/11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C696D-C5BD-43F3-998E-8432922331C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99637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3C211-CD59-48B5-BB03-990BEF642865}" type="datetimeFigureOut">
              <a:rPr lang="en-AU" smtClean="0"/>
              <a:t>30/11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C696D-C5BD-43F3-998E-8432922331C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55826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3C211-CD59-48B5-BB03-990BEF642865}" type="datetimeFigureOut">
              <a:rPr lang="en-AU" smtClean="0"/>
              <a:t>30/11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C696D-C5BD-43F3-998E-8432922331C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18968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3C211-CD59-48B5-BB03-990BEF642865}" type="datetimeFigureOut">
              <a:rPr lang="en-AU" smtClean="0"/>
              <a:t>30/11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C696D-C5BD-43F3-998E-8432922331C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57380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3C211-CD59-48B5-BB03-990BEF642865}" type="datetimeFigureOut">
              <a:rPr lang="en-AU" smtClean="0"/>
              <a:t>30/11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C696D-C5BD-43F3-998E-8432922331C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71515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3C211-CD59-48B5-BB03-990BEF642865}" type="datetimeFigureOut">
              <a:rPr lang="en-AU" smtClean="0"/>
              <a:t>30/11/202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C696D-C5BD-43F3-998E-8432922331C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14171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3C211-CD59-48B5-BB03-990BEF642865}" type="datetimeFigureOut">
              <a:rPr lang="en-AU" smtClean="0"/>
              <a:t>30/11/202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C696D-C5BD-43F3-998E-8432922331C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67329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3C211-CD59-48B5-BB03-990BEF642865}" type="datetimeFigureOut">
              <a:rPr lang="en-AU" smtClean="0"/>
              <a:t>30/11/202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C696D-C5BD-43F3-998E-8432922331C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55612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3C211-CD59-48B5-BB03-990BEF642865}" type="datetimeFigureOut">
              <a:rPr lang="en-AU" smtClean="0"/>
              <a:t>30/11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C696D-C5BD-43F3-998E-8432922331C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775441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E3C211-CD59-48B5-BB03-990BEF642865}" type="datetimeFigureOut">
              <a:rPr lang="en-AU" smtClean="0"/>
              <a:t>30/11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C696D-C5BD-43F3-998E-8432922331C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54498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E3C211-CD59-48B5-BB03-990BEF642865}" type="datetimeFigureOut">
              <a:rPr lang="en-AU" smtClean="0"/>
              <a:t>30/11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C696D-C5BD-43F3-998E-8432922331C3}" type="slidenum">
              <a:rPr lang="en-AU" smtClean="0"/>
              <a:t>‹#›</a:t>
            </a:fld>
            <a:endParaRPr lang="en-AU"/>
          </a:p>
        </p:txBody>
      </p:sp>
      <p:sp>
        <p:nvSpPr>
          <p:cNvPr id="7" name="MSIPCMContentMarking" descr="{&quot;HashCode&quot;:1610746136,&quot;Placement&quot;:&quot;Header&quot;,&quot;Top&quot;:0.0,&quot;Left&quot;:188.729141,&quot;SlideWidth&quot;:540,&quot;SlideHeight&quot;:720}">
            <a:extLst>
              <a:ext uri="{FF2B5EF4-FFF2-40B4-BE49-F238E27FC236}">
                <a16:creationId xmlns:a16="http://schemas.microsoft.com/office/drawing/2014/main" id="{BA8624D0-F252-58B9-7C1E-8D740D72F598}"/>
              </a:ext>
            </a:extLst>
          </p:cNvPr>
          <p:cNvSpPr txBox="1"/>
          <p:nvPr userDrawn="1"/>
        </p:nvSpPr>
        <p:spPr>
          <a:xfrm>
            <a:off x="2396860" y="0"/>
            <a:ext cx="2064281" cy="296525"/>
          </a:xfrm>
          <a:prstGeom prst="rect">
            <a:avLst/>
          </a:prstGeom>
          <a:noFill/>
        </p:spPr>
        <p:txBody>
          <a:bodyPr vert="horz" wrap="square" lIns="0" tIns="0" rIns="0" bIns="0" rtlCol="0" anchor="ctr" anchorCtr="1">
            <a:spAutoFit/>
          </a:bodyPr>
          <a:lstStyle/>
          <a:p>
            <a:pPr algn="ctr">
              <a:spcBef>
                <a:spcPts val="0"/>
              </a:spcBef>
              <a:spcAft>
                <a:spcPts val="0"/>
              </a:spcAft>
            </a:pPr>
            <a:r>
              <a:rPr lang="en-AU" sz="1200">
                <a:solidFill>
                  <a:srgbClr val="EEDC00"/>
                </a:solidFill>
                <a:latin typeface="Calibri" panose="020F0502020204030204" pitchFamily="34" charset="0"/>
              </a:rPr>
              <a:t>RMIT Classification: Trusted</a:t>
            </a:r>
          </a:p>
        </p:txBody>
      </p:sp>
    </p:spTree>
    <p:extLst>
      <p:ext uri="{BB962C8B-B14F-4D97-AF65-F5344CB8AC3E}">
        <p14:creationId xmlns:p14="http://schemas.microsoft.com/office/powerpoint/2010/main" val="2457092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7.tif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13.emf"/><Relationship Id="rId3" Type="http://schemas.openxmlformats.org/officeDocument/2006/relationships/image" Target="../media/image8.emf"/><Relationship Id="rId7" Type="http://schemas.openxmlformats.org/officeDocument/2006/relationships/image" Target="../media/image10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15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12.emf"/><Relationship Id="rId5" Type="http://schemas.openxmlformats.org/officeDocument/2006/relationships/image" Target="../media/image9.emf"/><Relationship Id="rId15" Type="http://schemas.openxmlformats.org/officeDocument/2006/relationships/image" Target="../media/image14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11.emf"/><Relationship Id="rId1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A0CAEFBD-E6AA-9219-7302-A2BDE0122857}"/>
              </a:ext>
            </a:extLst>
          </p:cNvPr>
          <p:cNvGrpSpPr/>
          <p:nvPr/>
        </p:nvGrpSpPr>
        <p:grpSpPr>
          <a:xfrm>
            <a:off x="204397" y="1341120"/>
            <a:ext cx="6309360" cy="2606040"/>
            <a:chOff x="387213" y="1674912"/>
            <a:chExt cx="10800000" cy="4322635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0688282C-C958-695C-571C-4BF4A400E99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7213" y="1674912"/>
              <a:ext cx="10800000" cy="4322635"/>
            </a:xfrm>
            <a:prstGeom prst="rect">
              <a:avLst/>
            </a:prstGeom>
          </p:spPr>
        </p:pic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B5980D7F-E6C1-A3EF-FA6F-8CD5DED4BA08}"/>
                </a:ext>
              </a:extLst>
            </p:cNvPr>
            <p:cNvCxnSpPr/>
            <p:nvPr/>
          </p:nvCxnSpPr>
          <p:spPr>
            <a:xfrm>
              <a:off x="2605480" y="3183466"/>
              <a:ext cx="626533" cy="0"/>
            </a:xfrm>
            <a:prstGeom prst="straightConnector1">
              <a:avLst/>
            </a:prstGeom>
            <a:ln w="254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1B6AE1DA-8EE7-6ADE-7687-F43C52D1E651}"/>
                </a:ext>
              </a:extLst>
            </p:cNvPr>
            <p:cNvCxnSpPr>
              <a:cxnSpLocks/>
            </p:cNvCxnSpPr>
            <p:nvPr/>
          </p:nvCxnSpPr>
          <p:spPr>
            <a:xfrm>
              <a:off x="4502013" y="2023532"/>
              <a:ext cx="931333" cy="0"/>
            </a:xfrm>
            <a:prstGeom prst="straightConnector1">
              <a:avLst/>
            </a:prstGeom>
            <a:ln w="254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B9A98ECC-0296-7366-3D2A-A6476DBB827E}"/>
                </a:ext>
              </a:extLst>
            </p:cNvPr>
            <p:cNvCxnSpPr>
              <a:cxnSpLocks/>
            </p:cNvCxnSpPr>
            <p:nvPr/>
          </p:nvCxnSpPr>
          <p:spPr>
            <a:xfrm>
              <a:off x="6779546" y="2023532"/>
              <a:ext cx="931333" cy="0"/>
            </a:xfrm>
            <a:prstGeom prst="straightConnector1">
              <a:avLst/>
            </a:prstGeom>
            <a:ln w="254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0B450166-8FCB-3F36-D793-43B7E7EF922D}"/>
                </a:ext>
              </a:extLst>
            </p:cNvPr>
            <p:cNvCxnSpPr>
              <a:cxnSpLocks/>
            </p:cNvCxnSpPr>
            <p:nvPr/>
          </p:nvCxnSpPr>
          <p:spPr>
            <a:xfrm>
              <a:off x="9057079" y="2887132"/>
              <a:ext cx="931333" cy="0"/>
            </a:xfrm>
            <a:prstGeom prst="straightConnector1">
              <a:avLst/>
            </a:prstGeom>
            <a:ln w="254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A71E3D0F-AFFA-8F8D-1F56-D2296AFDB059}"/>
                </a:ext>
              </a:extLst>
            </p:cNvPr>
            <p:cNvCxnSpPr>
              <a:cxnSpLocks/>
            </p:cNvCxnSpPr>
            <p:nvPr/>
          </p:nvCxnSpPr>
          <p:spPr>
            <a:xfrm>
              <a:off x="10218748" y="2049696"/>
              <a:ext cx="931332" cy="0"/>
            </a:xfrm>
            <a:prstGeom prst="straightConnector1">
              <a:avLst/>
            </a:prstGeom>
            <a:ln w="254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668C61C5-4D1D-6E1E-11CB-29A2EF4AF014}"/>
                </a:ext>
              </a:extLst>
            </p:cNvPr>
            <p:cNvCxnSpPr>
              <a:cxnSpLocks/>
            </p:cNvCxnSpPr>
            <p:nvPr/>
          </p:nvCxnSpPr>
          <p:spPr>
            <a:xfrm>
              <a:off x="2453079" y="4555065"/>
              <a:ext cx="931333" cy="0"/>
            </a:xfrm>
            <a:prstGeom prst="straightConnector1">
              <a:avLst/>
            </a:prstGeom>
            <a:ln w="254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37ED221A-108A-102B-C00B-EF7B56567CDF}"/>
                </a:ext>
              </a:extLst>
            </p:cNvPr>
            <p:cNvCxnSpPr>
              <a:cxnSpLocks/>
            </p:cNvCxnSpPr>
            <p:nvPr/>
          </p:nvCxnSpPr>
          <p:spPr>
            <a:xfrm>
              <a:off x="4408879" y="4343400"/>
              <a:ext cx="931333" cy="0"/>
            </a:xfrm>
            <a:prstGeom prst="straightConnector1">
              <a:avLst/>
            </a:prstGeom>
            <a:ln w="254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19922998-8779-4243-84CC-19D507CFDB69}"/>
                </a:ext>
              </a:extLst>
            </p:cNvPr>
            <p:cNvCxnSpPr>
              <a:cxnSpLocks/>
            </p:cNvCxnSpPr>
            <p:nvPr/>
          </p:nvCxnSpPr>
          <p:spPr>
            <a:xfrm>
              <a:off x="6644078" y="4368795"/>
              <a:ext cx="931333" cy="0"/>
            </a:xfrm>
            <a:prstGeom prst="straightConnector1">
              <a:avLst/>
            </a:prstGeom>
            <a:ln w="254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F3CABC7C-B1B5-B8D1-2A40-5D0FD4C2DF2D}"/>
                </a:ext>
              </a:extLst>
            </p:cNvPr>
            <p:cNvCxnSpPr>
              <a:cxnSpLocks/>
            </p:cNvCxnSpPr>
            <p:nvPr/>
          </p:nvCxnSpPr>
          <p:spPr>
            <a:xfrm>
              <a:off x="5985411" y="5291662"/>
              <a:ext cx="4233336" cy="0"/>
            </a:xfrm>
            <a:prstGeom prst="straightConnector1">
              <a:avLst/>
            </a:prstGeom>
            <a:ln w="25400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4EC26EED-95A3-D76C-A310-0C27E0134C2F}"/>
              </a:ext>
            </a:extLst>
          </p:cNvPr>
          <p:cNvSpPr txBox="1"/>
          <p:nvPr/>
        </p:nvSpPr>
        <p:spPr>
          <a:xfrm>
            <a:off x="204397" y="630316"/>
            <a:ext cx="1539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b="1" dirty="0">
                <a:cs typeface="Arial" panose="020B0604020202020204" pitchFamily="34" charset="0"/>
              </a:rPr>
              <a:t>Figure S1</a:t>
            </a:r>
            <a:endParaRPr lang="en-AU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27534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48">
            <a:extLst>
              <a:ext uri="{FF2B5EF4-FFF2-40B4-BE49-F238E27FC236}">
                <a16:creationId xmlns:a16="http://schemas.microsoft.com/office/drawing/2014/main" id="{DF5175B7-CC78-1439-86B7-EA3B207293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29501" y="3351288"/>
            <a:ext cx="1621851" cy="2558696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9321B07A-C8A1-C36D-B908-AAE6BD99BD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56931" y="3854557"/>
            <a:ext cx="1625796" cy="2057970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B6FD89AF-C5D7-4A0D-998F-D6527850AEC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7567" y="3316956"/>
            <a:ext cx="1615445" cy="2596981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8520861E-AAFD-3C41-B153-0A9B17123EF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6824" y="6127811"/>
            <a:ext cx="1915388" cy="2817402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C1C99B3D-D8DB-6505-6E92-4662E5FE626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80390" y="6108228"/>
            <a:ext cx="1913919" cy="2837497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048E592B-6A71-0CB1-0E2A-609B17ABEF3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33185" y="410454"/>
            <a:ext cx="5286705" cy="2519905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42998BAA-EE9E-CDF3-B916-E9440BD30741}"/>
              </a:ext>
            </a:extLst>
          </p:cNvPr>
          <p:cNvSpPr/>
          <p:nvPr/>
        </p:nvSpPr>
        <p:spPr>
          <a:xfrm>
            <a:off x="5029015" y="7284867"/>
            <a:ext cx="194069" cy="215631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  <a:effectLst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55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BABE22B-CE22-5F40-067E-BA2FE6AF6928}"/>
              </a:ext>
            </a:extLst>
          </p:cNvPr>
          <p:cNvSpPr/>
          <p:nvPr/>
        </p:nvSpPr>
        <p:spPr>
          <a:xfrm>
            <a:off x="5029015" y="7674482"/>
            <a:ext cx="194069" cy="215631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  <a:effectLst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55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437E3ED-76F3-7D81-63EF-1D056AE202B4}"/>
              </a:ext>
            </a:extLst>
          </p:cNvPr>
          <p:cNvSpPr txBox="1"/>
          <p:nvPr/>
        </p:nvSpPr>
        <p:spPr>
          <a:xfrm>
            <a:off x="325943" y="3183811"/>
            <a:ext cx="303288" cy="3470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55" b="1" dirty="0"/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D4434CD-4646-6A22-33B7-E67D6A676A33}"/>
              </a:ext>
            </a:extLst>
          </p:cNvPr>
          <p:cNvSpPr txBox="1"/>
          <p:nvPr/>
        </p:nvSpPr>
        <p:spPr>
          <a:xfrm>
            <a:off x="2384132" y="3183811"/>
            <a:ext cx="296876" cy="3470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55" b="1" dirty="0"/>
              <a:t>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E1ED880-8508-A8D6-34E4-C79723B40352}"/>
              </a:ext>
            </a:extLst>
          </p:cNvPr>
          <p:cNvSpPr txBox="1"/>
          <p:nvPr/>
        </p:nvSpPr>
        <p:spPr>
          <a:xfrm>
            <a:off x="325943" y="212922"/>
            <a:ext cx="312906" cy="3470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55" b="1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778A890-14D4-5412-AB19-78F36AF6BFA2}"/>
              </a:ext>
            </a:extLst>
          </p:cNvPr>
          <p:cNvSpPr txBox="1"/>
          <p:nvPr/>
        </p:nvSpPr>
        <p:spPr>
          <a:xfrm>
            <a:off x="4508441" y="3183811"/>
            <a:ext cx="317716" cy="3470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55" b="1" dirty="0"/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4182E22-73D0-D37D-0784-27350150DDC6}"/>
              </a:ext>
            </a:extLst>
          </p:cNvPr>
          <p:cNvSpPr txBox="1"/>
          <p:nvPr/>
        </p:nvSpPr>
        <p:spPr>
          <a:xfrm>
            <a:off x="325943" y="6138857"/>
            <a:ext cx="288862" cy="3470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55" b="1" dirty="0"/>
              <a:t>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85B9074-DB31-C16B-F31A-310919543534}"/>
              </a:ext>
            </a:extLst>
          </p:cNvPr>
          <p:cNvSpPr txBox="1"/>
          <p:nvPr/>
        </p:nvSpPr>
        <p:spPr>
          <a:xfrm>
            <a:off x="2384131" y="6161501"/>
            <a:ext cx="282450" cy="3470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55" b="1" dirty="0"/>
              <a:t>F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BF190F6-09F5-5B76-1B19-8F76A52798A9}"/>
              </a:ext>
            </a:extLst>
          </p:cNvPr>
          <p:cNvSpPr txBox="1"/>
          <p:nvPr/>
        </p:nvSpPr>
        <p:spPr>
          <a:xfrm>
            <a:off x="5239261" y="7222846"/>
            <a:ext cx="676788" cy="3470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55" b="1" dirty="0"/>
              <a:t>Sham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0DF4C96-9967-22B1-7D0E-8999965E6B70}"/>
              </a:ext>
            </a:extLst>
          </p:cNvPr>
          <p:cNvSpPr txBox="1"/>
          <p:nvPr/>
        </p:nvSpPr>
        <p:spPr>
          <a:xfrm>
            <a:off x="5239262" y="7612461"/>
            <a:ext cx="397866" cy="3470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55" b="1" dirty="0"/>
              <a:t>CS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CF8B3969-2440-84BF-97C2-3C581185F4D6}"/>
              </a:ext>
            </a:extLst>
          </p:cNvPr>
          <p:cNvCxnSpPr>
            <a:cxnSpLocks/>
          </p:cNvCxnSpPr>
          <p:nvPr/>
        </p:nvCxnSpPr>
        <p:spPr>
          <a:xfrm>
            <a:off x="6019890" y="933570"/>
            <a:ext cx="169342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1E003E50-3A79-1538-5148-9C34F2D2FFFA}"/>
              </a:ext>
            </a:extLst>
          </p:cNvPr>
          <p:cNvCxnSpPr/>
          <p:nvPr/>
        </p:nvCxnSpPr>
        <p:spPr>
          <a:xfrm flipV="1">
            <a:off x="6189233" y="933570"/>
            <a:ext cx="0" cy="769235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12C9A77A-DF27-5BE5-F748-3C69631CE5B5}"/>
              </a:ext>
            </a:extLst>
          </p:cNvPr>
          <p:cNvCxnSpPr>
            <a:cxnSpLocks/>
          </p:cNvCxnSpPr>
          <p:nvPr/>
        </p:nvCxnSpPr>
        <p:spPr>
          <a:xfrm flipV="1">
            <a:off x="1469804" y="2697902"/>
            <a:ext cx="0" cy="126224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87F0A74D-C723-16E2-FA33-1D057A56EA43}"/>
              </a:ext>
            </a:extLst>
          </p:cNvPr>
          <p:cNvCxnSpPr>
            <a:cxnSpLocks/>
          </p:cNvCxnSpPr>
          <p:nvPr/>
        </p:nvCxnSpPr>
        <p:spPr>
          <a:xfrm>
            <a:off x="1468877" y="2817249"/>
            <a:ext cx="2240437" cy="6877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524CB450-976D-34CA-5184-F9945C1B8390}"/>
              </a:ext>
            </a:extLst>
          </p:cNvPr>
          <p:cNvCxnSpPr>
            <a:cxnSpLocks/>
          </p:cNvCxnSpPr>
          <p:nvPr/>
        </p:nvCxnSpPr>
        <p:spPr>
          <a:xfrm flipV="1">
            <a:off x="3706100" y="2679186"/>
            <a:ext cx="0" cy="134485"/>
          </a:xfrm>
          <a:prstGeom prst="line">
            <a:avLst/>
          </a:prstGeom>
          <a:ln w="19050">
            <a:solidFill>
              <a:srgbClr val="C0000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0B855955-B1AB-51B4-7C58-82C9E791B28F}"/>
              </a:ext>
            </a:extLst>
          </p:cNvPr>
          <p:cNvSpPr txBox="1"/>
          <p:nvPr/>
        </p:nvSpPr>
        <p:spPr>
          <a:xfrm rot="16200000">
            <a:off x="518566" y="859820"/>
            <a:ext cx="409087" cy="20556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736" dirty="0"/>
              <a:t>FSC-H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A0F7FED-6E79-8FC9-5369-0C4A863703D0}"/>
              </a:ext>
            </a:extLst>
          </p:cNvPr>
          <p:cNvSpPr txBox="1"/>
          <p:nvPr/>
        </p:nvSpPr>
        <p:spPr>
          <a:xfrm rot="16200000">
            <a:off x="266558" y="2174115"/>
            <a:ext cx="903842" cy="20556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36" dirty="0"/>
              <a:t>Anti-CD4 AF70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4F7AE55-0461-6761-EAD2-25091D9B0289}"/>
              </a:ext>
            </a:extLst>
          </p:cNvPr>
          <p:cNvSpPr txBox="1"/>
          <p:nvPr/>
        </p:nvSpPr>
        <p:spPr>
          <a:xfrm rot="16200000">
            <a:off x="1607660" y="2174115"/>
            <a:ext cx="903842" cy="20556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36" dirty="0"/>
              <a:t>Anti-CD44 PE-Cy7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FF52044-5845-BBF2-2370-257A50951651}"/>
              </a:ext>
            </a:extLst>
          </p:cNvPr>
          <p:cNvSpPr txBox="1"/>
          <p:nvPr/>
        </p:nvSpPr>
        <p:spPr>
          <a:xfrm rot="16200000">
            <a:off x="2949444" y="2174115"/>
            <a:ext cx="903842" cy="20556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36" dirty="0"/>
              <a:t>Anti-CD44 PE-Cy7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17B3C2D-371E-F64B-0937-B8BBCCC8780C}"/>
              </a:ext>
            </a:extLst>
          </p:cNvPr>
          <p:cNvSpPr txBox="1"/>
          <p:nvPr/>
        </p:nvSpPr>
        <p:spPr>
          <a:xfrm>
            <a:off x="919176" y="2851747"/>
            <a:ext cx="903842" cy="20556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36" dirty="0"/>
              <a:t>Anti-CD8 v45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01E67A3-E64E-2009-BC38-3407B1BEB421}"/>
              </a:ext>
            </a:extLst>
          </p:cNvPr>
          <p:cNvSpPr txBox="1"/>
          <p:nvPr/>
        </p:nvSpPr>
        <p:spPr>
          <a:xfrm>
            <a:off x="2287304" y="2851747"/>
            <a:ext cx="903842" cy="20556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36" dirty="0"/>
              <a:t>Anti-CD62L SB60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7A2DA90-52B9-79C9-1D8A-4AD78F7E675D}"/>
              </a:ext>
            </a:extLst>
          </p:cNvPr>
          <p:cNvSpPr txBox="1"/>
          <p:nvPr/>
        </p:nvSpPr>
        <p:spPr>
          <a:xfrm>
            <a:off x="3680991" y="2851747"/>
            <a:ext cx="903842" cy="20556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36" dirty="0"/>
              <a:t>Anti-CD62L SB600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312E21D2-A98C-4590-8F68-116CCC85B519}"/>
              </a:ext>
            </a:extLst>
          </p:cNvPr>
          <p:cNvCxnSpPr>
            <a:cxnSpLocks/>
          </p:cNvCxnSpPr>
          <p:nvPr/>
        </p:nvCxnSpPr>
        <p:spPr>
          <a:xfrm>
            <a:off x="1237303" y="2062657"/>
            <a:ext cx="1120171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534DDAFB-40AF-C052-30E6-BCB89AE489D4}"/>
              </a:ext>
            </a:extLst>
          </p:cNvPr>
          <p:cNvSpPr txBox="1"/>
          <p:nvPr/>
        </p:nvSpPr>
        <p:spPr>
          <a:xfrm>
            <a:off x="1024353" y="1509022"/>
            <a:ext cx="903842" cy="20556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36" dirty="0"/>
              <a:t>FSC-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745F775-E7F2-0FF4-119F-3EAD23DBA165}"/>
              </a:ext>
            </a:extLst>
          </p:cNvPr>
          <p:cNvSpPr txBox="1"/>
          <p:nvPr/>
        </p:nvSpPr>
        <p:spPr>
          <a:xfrm>
            <a:off x="2287304" y="1509022"/>
            <a:ext cx="903842" cy="20556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36" dirty="0"/>
              <a:t>FSC-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2760B4E-9192-8AD6-A117-701A008D2670}"/>
              </a:ext>
            </a:extLst>
          </p:cNvPr>
          <p:cNvSpPr txBox="1"/>
          <p:nvPr/>
        </p:nvSpPr>
        <p:spPr>
          <a:xfrm>
            <a:off x="3674342" y="1509022"/>
            <a:ext cx="903842" cy="20556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36" dirty="0"/>
              <a:t>FSC-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299E0E3-40AC-973A-724E-F0A941C2F332}"/>
              </a:ext>
            </a:extLst>
          </p:cNvPr>
          <p:cNvSpPr txBox="1"/>
          <p:nvPr/>
        </p:nvSpPr>
        <p:spPr>
          <a:xfrm>
            <a:off x="5069642" y="1509022"/>
            <a:ext cx="903842" cy="20556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36" dirty="0"/>
              <a:t>FSC-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EF107CA-78AA-BA02-75B4-B5E8CC01E549}"/>
              </a:ext>
            </a:extLst>
          </p:cNvPr>
          <p:cNvSpPr txBox="1"/>
          <p:nvPr/>
        </p:nvSpPr>
        <p:spPr>
          <a:xfrm rot="16200000">
            <a:off x="4242867" y="859820"/>
            <a:ext cx="1104301" cy="20556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36" dirty="0"/>
              <a:t>Anti-CD3 PerCP-Cy5.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7EA53AF-8FD1-9A98-27A5-FF1F477C54F2}"/>
              </a:ext>
            </a:extLst>
          </p:cNvPr>
          <p:cNvSpPr txBox="1"/>
          <p:nvPr/>
        </p:nvSpPr>
        <p:spPr>
          <a:xfrm rot="16200000">
            <a:off x="2839642" y="859820"/>
            <a:ext cx="1104301" cy="20556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736" dirty="0"/>
              <a:t>Live/Dead Near IR Stain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CA3E2A2-5EB1-AD04-743C-AACC17036CC7}"/>
              </a:ext>
            </a:extLst>
          </p:cNvPr>
          <p:cNvSpPr txBox="1"/>
          <p:nvPr/>
        </p:nvSpPr>
        <p:spPr>
          <a:xfrm rot="16200000">
            <a:off x="1879606" y="865142"/>
            <a:ext cx="404278" cy="19492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>
              <a:lnSpc>
                <a:spcPts val="791"/>
              </a:lnSpc>
            </a:pPr>
            <a:r>
              <a:rPr lang="en-US" sz="736" dirty="0"/>
              <a:t>SSC-A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A3068F0F-3F44-4006-F4FD-536A426929A7}"/>
              </a:ext>
            </a:extLst>
          </p:cNvPr>
          <p:cNvCxnSpPr/>
          <p:nvPr/>
        </p:nvCxnSpPr>
        <p:spPr>
          <a:xfrm>
            <a:off x="1607872" y="862901"/>
            <a:ext cx="749602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E6C50A50-BB15-F132-B168-0612D181DC56}"/>
              </a:ext>
            </a:extLst>
          </p:cNvPr>
          <p:cNvCxnSpPr>
            <a:cxnSpLocks/>
          </p:cNvCxnSpPr>
          <p:nvPr/>
        </p:nvCxnSpPr>
        <p:spPr>
          <a:xfrm>
            <a:off x="2998262" y="1268510"/>
            <a:ext cx="711052" cy="1301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07C2DD0E-6337-9F6D-E38F-F992048DBDCF}"/>
              </a:ext>
            </a:extLst>
          </p:cNvPr>
          <p:cNvCxnSpPr>
            <a:cxnSpLocks/>
          </p:cNvCxnSpPr>
          <p:nvPr/>
        </p:nvCxnSpPr>
        <p:spPr>
          <a:xfrm>
            <a:off x="4628061" y="1268509"/>
            <a:ext cx="466669" cy="0"/>
          </a:xfrm>
          <a:prstGeom prst="straightConnector1">
            <a:avLst/>
          </a:prstGeom>
          <a:ln w="190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62192EA1-F2A8-0001-09E0-F6187D129D67}"/>
              </a:ext>
            </a:extLst>
          </p:cNvPr>
          <p:cNvCxnSpPr>
            <a:cxnSpLocks/>
          </p:cNvCxnSpPr>
          <p:nvPr/>
        </p:nvCxnSpPr>
        <p:spPr>
          <a:xfrm>
            <a:off x="1469805" y="1702805"/>
            <a:ext cx="4719428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3509D21F-5AD2-470C-0299-3A9AB7A510EE}"/>
              </a:ext>
            </a:extLst>
          </p:cNvPr>
          <p:cNvCxnSpPr>
            <a:cxnSpLocks/>
          </p:cNvCxnSpPr>
          <p:nvPr/>
        </p:nvCxnSpPr>
        <p:spPr>
          <a:xfrm>
            <a:off x="1476274" y="1699571"/>
            <a:ext cx="0" cy="134485"/>
          </a:xfrm>
          <a:prstGeom prst="line">
            <a:avLst/>
          </a:prstGeom>
          <a:ln w="19050">
            <a:solidFill>
              <a:srgbClr val="C0000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C3A44052-6A2F-E908-F84A-CC63A06292C5}"/>
              </a:ext>
            </a:extLst>
          </p:cNvPr>
          <p:cNvSpPr txBox="1"/>
          <p:nvPr/>
        </p:nvSpPr>
        <p:spPr>
          <a:xfrm>
            <a:off x="0" y="-18551"/>
            <a:ext cx="1539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b="1" dirty="0">
                <a:cs typeface="Arial" panose="020B0604020202020204" pitchFamily="34" charset="0"/>
              </a:rPr>
              <a:t>Figure S2</a:t>
            </a:r>
            <a:endParaRPr lang="en-AU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12574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FBA86CFC-B965-FD0D-DFBA-551166F78E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5127590"/>
              </p:ext>
            </p:extLst>
          </p:nvPr>
        </p:nvGraphicFramePr>
        <p:xfrm>
          <a:off x="528638" y="4557713"/>
          <a:ext cx="1511300" cy="1752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861638" imgH="3322061" progId="Prism10.Document">
                  <p:embed/>
                </p:oleObj>
              </mc:Choice>
              <mc:Fallback>
                <p:oleObj name="Prism 10" r:id="rId2" imgW="2861638" imgH="3322061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FBA86CFC-B965-FD0D-DFBA-551166F78E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28638" y="4557713"/>
                        <a:ext cx="1511300" cy="1752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8A04B481-E78C-C27F-14A5-97AD180BA7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2454992"/>
              </p:ext>
            </p:extLst>
          </p:nvPr>
        </p:nvGraphicFramePr>
        <p:xfrm>
          <a:off x="528063" y="1998100"/>
          <a:ext cx="1512000" cy="17001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878565" imgH="3235744" progId="Prism10.Document">
                  <p:embed/>
                </p:oleObj>
              </mc:Choice>
              <mc:Fallback>
                <p:oleObj name="Prism 10" r:id="rId4" imgW="2878565" imgH="3235744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8A04B481-E78C-C27F-14A5-97AD180BA7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28063" y="1998100"/>
                        <a:ext cx="1512000" cy="17001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73CF5C62-B3FC-BFBB-5116-51C5DCD10E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3367127"/>
              </p:ext>
            </p:extLst>
          </p:nvPr>
        </p:nvGraphicFramePr>
        <p:xfrm>
          <a:off x="2009775" y="1809750"/>
          <a:ext cx="1512888" cy="1874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2907376" imgH="3602621" progId="Prism10.Document">
                  <p:embed/>
                </p:oleObj>
              </mc:Choice>
              <mc:Fallback>
                <p:oleObj name="Prism 10" r:id="rId6" imgW="2907376" imgH="3602621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73CF5C62-B3FC-BFBB-5116-51C5DCD10E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009775" y="1809750"/>
                        <a:ext cx="1512888" cy="1874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CC7AD86B-D97E-DEC3-338D-D3E3F20F36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6412080"/>
              </p:ext>
            </p:extLst>
          </p:nvPr>
        </p:nvGraphicFramePr>
        <p:xfrm>
          <a:off x="3429000" y="2120828"/>
          <a:ext cx="1512000" cy="15662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2981924" imgH="3086684" progId="Prism10.Document">
                  <p:embed/>
                </p:oleObj>
              </mc:Choice>
              <mc:Fallback>
                <p:oleObj name="Prism 10" r:id="rId8" imgW="2981924" imgH="3086684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CC7AD86B-D97E-DEC3-338D-D3E3F20F36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429000" y="2120828"/>
                        <a:ext cx="1512000" cy="15662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5650C8C0-581A-371D-9460-3A7ABCE2EC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9335837"/>
              </p:ext>
            </p:extLst>
          </p:nvPr>
        </p:nvGraphicFramePr>
        <p:xfrm>
          <a:off x="4910138" y="1971675"/>
          <a:ext cx="1512887" cy="1717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2986605" imgH="3390850" progId="Prism10.Document">
                  <p:embed/>
                </p:oleObj>
              </mc:Choice>
              <mc:Fallback>
                <p:oleObj name="Prism 10" r:id="rId10" imgW="2986605" imgH="3390850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5650C8C0-581A-371D-9460-3A7ABCE2EC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910138" y="1971675"/>
                        <a:ext cx="1512887" cy="1717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8E61596F-671E-C678-AF6E-C1EA9630D6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1504489"/>
              </p:ext>
            </p:extLst>
          </p:nvPr>
        </p:nvGraphicFramePr>
        <p:xfrm>
          <a:off x="1990725" y="4408488"/>
          <a:ext cx="1595438" cy="1906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3020098" imgH="3608743" progId="Prism10.Document">
                  <p:embed/>
                </p:oleObj>
              </mc:Choice>
              <mc:Fallback>
                <p:oleObj name="Prism 10" r:id="rId12" imgW="3020098" imgH="3608743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8E61596F-671E-C678-AF6E-C1EA9630D6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990725" y="4408488"/>
                        <a:ext cx="1595438" cy="1906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1059D3DF-644A-D311-B15A-06E50A1CA6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3407538"/>
              </p:ext>
            </p:extLst>
          </p:nvPr>
        </p:nvGraphicFramePr>
        <p:xfrm>
          <a:off x="3500464" y="4620479"/>
          <a:ext cx="1547812" cy="1697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2928624" imgH="3207892" progId="Prism10.Document">
                  <p:embed/>
                </p:oleObj>
              </mc:Choice>
              <mc:Fallback>
                <p:oleObj name="Prism 10" r:id="rId14" imgW="2928624" imgH="3207892" progId="Prism10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1059D3DF-644A-D311-B15A-06E50A1CA6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500464" y="4620479"/>
                        <a:ext cx="1547812" cy="1697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35696C28-4CBA-2A46-7C90-EA8DDF81CEF7}"/>
              </a:ext>
            </a:extLst>
          </p:cNvPr>
          <p:cNvSpPr txBox="1"/>
          <p:nvPr/>
        </p:nvSpPr>
        <p:spPr>
          <a:xfrm>
            <a:off x="204397" y="630316"/>
            <a:ext cx="1539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b="1" dirty="0">
                <a:cs typeface="Arial" panose="020B0604020202020204" pitchFamily="34" charset="0"/>
              </a:rPr>
              <a:t>Figure S3</a:t>
            </a:r>
            <a:endParaRPr lang="en-AU" dirty="0"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1125C83-F95C-0353-05F6-2ABE0A41277B}"/>
              </a:ext>
            </a:extLst>
          </p:cNvPr>
          <p:cNvSpPr txBox="1"/>
          <p:nvPr/>
        </p:nvSpPr>
        <p:spPr>
          <a:xfrm>
            <a:off x="2137428" y="1632635"/>
            <a:ext cx="305283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801" b="1" dirty="0"/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57281DB-5748-EB73-8287-463F0532EBCC}"/>
              </a:ext>
            </a:extLst>
          </p:cNvPr>
          <p:cNvSpPr txBox="1"/>
          <p:nvPr/>
        </p:nvSpPr>
        <p:spPr>
          <a:xfrm>
            <a:off x="610865" y="1632635"/>
            <a:ext cx="225428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801" b="1" dirty="0"/>
              <a:t>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9B07DF3-76AC-10C7-8E10-B6AD018EA6B3}"/>
              </a:ext>
            </a:extLst>
          </p:cNvPr>
          <p:cNvSpPr txBox="1"/>
          <p:nvPr/>
        </p:nvSpPr>
        <p:spPr>
          <a:xfrm>
            <a:off x="3632018" y="1632635"/>
            <a:ext cx="305283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801" b="1" dirty="0"/>
              <a:t>C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67FF9D9-AE68-DECA-B77A-789167C9ACB7}"/>
              </a:ext>
            </a:extLst>
          </p:cNvPr>
          <p:cNvSpPr txBox="1"/>
          <p:nvPr/>
        </p:nvSpPr>
        <p:spPr>
          <a:xfrm>
            <a:off x="4974475" y="1632635"/>
            <a:ext cx="305283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801" b="1" dirty="0"/>
              <a:t>D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FE567FC-D9E3-FEAF-D20A-B1D812BDA6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4641643"/>
              </p:ext>
            </p:extLst>
          </p:nvPr>
        </p:nvGraphicFramePr>
        <p:xfrm>
          <a:off x="4945063" y="4989513"/>
          <a:ext cx="1595437" cy="1320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6" imgW="3020098" imgH="2498749" progId="Prism10.Document">
                  <p:embed/>
                </p:oleObj>
              </mc:Choice>
              <mc:Fallback>
                <p:oleObj name="Prism 10" r:id="rId16" imgW="3020098" imgH="2498749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3FE567FC-D9E3-FEAF-D20A-B1D812BDA6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945063" y="4989513"/>
                        <a:ext cx="1595437" cy="1320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5785828-EFF5-EE84-A5FA-3EEEEFF80336}"/>
              </a:ext>
            </a:extLst>
          </p:cNvPr>
          <p:cNvSpPr txBox="1"/>
          <p:nvPr/>
        </p:nvSpPr>
        <p:spPr>
          <a:xfrm>
            <a:off x="2127198" y="4369256"/>
            <a:ext cx="305283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801" b="1" dirty="0"/>
              <a:t>F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69EB5B9-2428-E5D1-2942-D4CD840B16A4}"/>
              </a:ext>
            </a:extLst>
          </p:cNvPr>
          <p:cNvSpPr txBox="1"/>
          <p:nvPr/>
        </p:nvSpPr>
        <p:spPr>
          <a:xfrm>
            <a:off x="600635" y="4369256"/>
            <a:ext cx="225428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801" b="1" dirty="0"/>
              <a:t>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9602E97-EAD0-4ABE-4965-C43EFA902C6A}"/>
              </a:ext>
            </a:extLst>
          </p:cNvPr>
          <p:cNvSpPr txBox="1"/>
          <p:nvPr/>
        </p:nvSpPr>
        <p:spPr>
          <a:xfrm>
            <a:off x="3621788" y="4369256"/>
            <a:ext cx="305283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801" b="1" dirty="0"/>
              <a:t>G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7A8D9A5-6B50-D396-697B-70AE4C9B542A}"/>
              </a:ext>
            </a:extLst>
          </p:cNvPr>
          <p:cNvSpPr txBox="1"/>
          <p:nvPr/>
        </p:nvSpPr>
        <p:spPr>
          <a:xfrm>
            <a:off x="4964245" y="4369256"/>
            <a:ext cx="305283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801" b="1" dirty="0"/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2044586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4838</TotalTime>
  <Words>48</Words>
  <Application>Microsoft Office PowerPoint</Application>
  <PresentationFormat>On-screen Show (4:3)</PresentationFormat>
  <Paragraphs>33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10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k Him Fung</dc:creator>
  <cp:lastModifiedBy>Steven Bozinovski</cp:lastModifiedBy>
  <cp:revision>29</cp:revision>
  <dcterms:created xsi:type="dcterms:W3CDTF">2022-11-28T23:11:23Z</dcterms:created>
  <dcterms:modified xsi:type="dcterms:W3CDTF">2023-11-29T23:17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c3d088b-6243-4963-a2e2-8b321ab7f8fc_Enabled">
    <vt:lpwstr>true</vt:lpwstr>
  </property>
  <property fmtid="{D5CDD505-2E9C-101B-9397-08002B2CF9AE}" pid="3" name="MSIP_Label_8c3d088b-6243-4963-a2e2-8b321ab7f8fc_SetDate">
    <vt:lpwstr>2023-06-09T05:51:09Z</vt:lpwstr>
  </property>
  <property fmtid="{D5CDD505-2E9C-101B-9397-08002B2CF9AE}" pid="4" name="MSIP_Label_8c3d088b-6243-4963-a2e2-8b321ab7f8fc_Method">
    <vt:lpwstr>Standard</vt:lpwstr>
  </property>
  <property fmtid="{D5CDD505-2E9C-101B-9397-08002B2CF9AE}" pid="5" name="MSIP_Label_8c3d088b-6243-4963-a2e2-8b321ab7f8fc_Name">
    <vt:lpwstr>Trusted</vt:lpwstr>
  </property>
  <property fmtid="{D5CDD505-2E9C-101B-9397-08002B2CF9AE}" pid="6" name="MSIP_Label_8c3d088b-6243-4963-a2e2-8b321ab7f8fc_SiteId">
    <vt:lpwstr>d1323671-cdbe-4417-b4d4-bdb24b51316b</vt:lpwstr>
  </property>
  <property fmtid="{D5CDD505-2E9C-101B-9397-08002B2CF9AE}" pid="7" name="MSIP_Label_8c3d088b-6243-4963-a2e2-8b321ab7f8fc_ActionId">
    <vt:lpwstr>54e85023-7646-45f1-9b22-8ec475d7af09</vt:lpwstr>
  </property>
  <property fmtid="{D5CDD505-2E9C-101B-9397-08002B2CF9AE}" pid="8" name="MSIP_Label_8c3d088b-6243-4963-a2e2-8b321ab7f8fc_ContentBits">
    <vt:lpwstr>1</vt:lpwstr>
  </property>
</Properties>
</file>